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1884" y="-82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561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5573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339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4722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008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5483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6739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02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1662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2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0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944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66946" y="2493293"/>
            <a:ext cx="5510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correlation between liver TG content and liver weigh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6946" y="5289317"/>
            <a:ext cx="60863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10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000" b="1" smtClean="0"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correlation between plasma ALT and AST level to the liver TG conten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13854" y="611560"/>
            <a:ext cx="396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02804" y="3211537"/>
            <a:ext cx="396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36712" y="856159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91</a:t>
            </a:r>
          </a:p>
          <a:p>
            <a:r>
              <a:rPr lang="en-GB" sz="7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-value &lt; 0.000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36712" y="3458339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91</a:t>
            </a:r>
          </a:p>
          <a:p>
            <a:r>
              <a:rPr lang="en-GB" sz="7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-value &lt; 0.0001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583705" y="3456831"/>
            <a:ext cx="12241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36</a:t>
            </a:r>
          </a:p>
          <a:p>
            <a:r>
              <a:rPr lang="en-GB" sz="7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-value = 0.0122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814"/>
          <a:stretch/>
        </p:blipFill>
        <p:spPr bwMode="auto">
          <a:xfrm>
            <a:off x="296863" y="3259162"/>
            <a:ext cx="2636837" cy="2139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3167" y="3240112"/>
            <a:ext cx="3132137" cy="2139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915" y="712143"/>
            <a:ext cx="2436813" cy="189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32925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50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sli, Fenni</dc:creator>
  <cp:lastModifiedBy>Fenni Rusli</cp:lastModifiedBy>
  <cp:revision>7</cp:revision>
  <dcterms:created xsi:type="dcterms:W3CDTF">2013-12-19T15:51:17Z</dcterms:created>
  <dcterms:modified xsi:type="dcterms:W3CDTF">2014-11-17T00:25:29Z</dcterms:modified>
</cp:coreProperties>
</file>